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dhuravasal Krishnan, Janani (jananimk)" userId="6969b20d-d298-4095-ade9-5a3c5ff7904a" providerId="ADAL" clId="{51F5E749-6C92-4ECC-9F2B-969E2BC35D5B}"/>
    <pc:docChg chg="modSld">
      <pc:chgData name="Madhuravasal Krishnan, Janani (jananimk)" userId="6969b20d-d298-4095-ade9-5a3c5ff7904a" providerId="ADAL" clId="{51F5E749-6C92-4ECC-9F2B-969E2BC35D5B}" dt="2024-07-11T18:37:36.944" v="32" actId="123"/>
      <pc:docMkLst>
        <pc:docMk/>
      </pc:docMkLst>
      <pc:sldChg chg="modSp">
        <pc:chgData name="Madhuravasal Krishnan, Janani (jananimk)" userId="6969b20d-d298-4095-ade9-5a3c5ff7904a" providerId="ADAL" clId="{51F5E749-6C92-4ECC-9F2B-969E2BC35D5B}" dt="2024-07-11T18:37:36.944" v="32" actId="123"/>
        <pc:sldMkLst>
          <pc:docMk/>
          <pc:sldMk cId="3010969667" sldId="260"/>
        </pc:sldMkLst>
        <pc:spChg chg="mod">
          <ac:chgData name="Madhuravasal Krishnan, Janani (jananimk)" userId="6969b20d-d298-4095-ade9-5a3c5ff7904a" providerId="ADAL" clId="{51F5E749-6C92-4ECC-9F2B-969E2BC35D5B}" dt="2024-07-11T18:37:36.944" v="32" actId="123"/>
          <ac:spMkLst>
            <pc:docMk/>
            <pc:sldMk cId="3010969667" sldId="260"/>
            <ac:spMk id="7" creationId="{C5C367B7-6D0A-4ADE-9301-CA7D1FC23FDF}"/>
          </ac:spMkLst>
        </pc:spChg>
        <pc:graphicFrameChg chg="mod">
          <ac:chgData name="Madhuravasal Krishnan, Janani (jananimk)" userId="6969b20d-d298-4095-ade9-5a3c5ff7904a" providerId="ADAL" clId="{51F5E749-6C92-4ECC-9F2B-969E2BC35D5B}" dt="2024-07-11T18:37:21.653" v="27" actId="1035"/>
          <ac:graphicFrameMkLst>
            <pc:docMk/>
            <pc:sldMk cId="3010969667" sldId="260"/>
            <ac:graphicFrameMk id="6" creationId="{C709BB86-BDFB-4110-BD84-FEF36B6278EE}"/>
          </ac:graphicFrameMkLst>
        </pc:graphicFrameChg>
        <pc:graphicFrameChg chg="mod">
          <ac:chgData name="Madhuravasal Krishnan, Janani (jananimk)" userId="6969b20d-d298-4095-ade9-5a3c5ff7904a" providerId="ADAL" clId="{51F5E749-6C92-4ECC-9F2B-969E2BC35D5B}" dt="2024-07-11T18:37:26.192" v="28" actId="1036"/>
          <ac:graphicFrameMkLst>
            <pc:docMk/>
            <pc:sldMk cId="3010969667" sldId="260"/>
            <ac:graphicFrameMk id="8" creationId="{63791CBA-6765-4F47-838A-EF70BF856720}"/>
          </ac:graphicFrameMkLst>
        </pc:graphicFrameChg>
      </pc:sldChg>
    </pc:docChg>
  </pc:docChgLst>
  <pc:docChgLst>
    <pc:chgData name="Madhuravasal Krishnan, Janani (jananimk)" userId="6969b20d-d298-4095-ade9-5a3c5ff7904a" providerId="ADAL" clId="{A6C766AD-B7F2-4A56-81F8-96BD2566875E}"/>
    <pc:docChg chg="addSld delSld modSld">
      <pc:chgData name="Madhuravasal Krishnan, Janani (jananimk)" userId="6969b20d-d298-4095-ade9-5a3c5ff7904a" providerId="ADAL" clId="{A6C766AD-B7F2-4A56-81F8-96BD2566875E}" dt="2024-06-12T20:09:06.865" v="24" actId="20577"/>
      <pc:docMkLst>
        <pc:docMk/>
      </pc:docMkLst>
      <pc:sldChg chg="modSp add">
        <pc:chgData name="Madhuravasal Krishnan, Janani (jananimk)" userId="6969b20d-d298-4095-ade9-5a3c5ff7904a" providerId="ADAL" clId="{A6C766AD-B7F2-4A56-81F8-96BD2566875E}" dt="2024-06-12T20:09:06.865" v="24" actId="20577"/>
        <pc:sldMkLst>
          <pc:docMk/>
          <pc:sldMk cId="3010969667" sldId="260"/>
        </pc:sldMkLst>
        <pc:spChg chg="mod">
          <ac:chgData name="Madhuravasal Krishnan, Janani (jananimk)" userId="6969b20d-d298-4095-ade9-5a3c5ff7904a" providerId="ADAL" clId="{A6C766AD-B7F2-4A56-81F8-96BD2566875E}" dt="2024-06-12T20:09:06.865" v="24" actId="20577"/>
          <ac:spMkLst>
            <pc:docMk/>
            <pc:sldMk cId="3010969667" sldId="260"/>
            <ac:spMk id="7" creationId="{C5C367B7-6D0A-4ADE-9301-CA7D1FC23FDF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mailuc-my.sharepoint.com/personal/jananimk_ucmail_uc_edu/Documents/202/2023/T%20cell%20isolation/PCR%20results%20for%20controls%2063,66,37,62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mailuc-my.sharepoint.com/personal/jananimk_ucmail_uc_edu/Documents/202/2023/T%20cell%20isolation/Day%203-%20p24%20ELISA%20and%20pol%20genePCR%20results%20(project%20control%2073)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521867612063069"/>
          <c:y val="7.3878196074239774E-2"/>
          <c:w val="0.71529991677869531"/>
          <c:h val="0.4915912995014544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ontrol 62'!$I$18:$L$1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2400127101182299</c:v>
                  </c:pt>
                  <c:pt idx="2">
                    <c:v>6.0522776115856075E-2</c:v>
                  </c:pt>
                  <c:pt idx="3">
                    <c:v>0.29502061715515315</c:v>
                  </c:pt>
                </c:numCache>
              </c:numRef>
            </c:plus>
            <c:minus>
              <c:numRef>
                <c:f>'Control 62'!$I$18:$L$1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2400127101182299</c:v>
                  </c:pt>
                  <c:pt idx="2">
                    <c:v>6.0522776115856075E-2</c:v>
                  </c:pt>
                  <c:pt idx="3">
                    <c:v>0.295020617155153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ntrol 62'!$I$16:$L$16</c:f>
              <c:strCache>
                <c:ptCount val="4"/>
                <c:pt idx="0">
                  <c:v>No HIV/ no drug</c:v>
                </c:pt>
                <c:pt idx="1">
                  <c:v>HIV/no drug</c:v>
                </c:pt>
                <c:pt idx="2">
                  <c:v>HIV+10ug fentanyl</c:v>
                </c:pt>
                <c:pt idx="3">
                  <c:v>HIV+10ug fentanyl+10ug naltrexone</c:v>
                </c:pt>
              </c:strCache>
            </c:strRef>
          </c:cat>
          <c:val>
            <c:numRef>
              <c:f>'Control 62'!$I$17:$L$17</c:f>
              <c:numCache>
                <c:formatCode>General</c:formatCode>
                <c:ptCount val="4"/>
                <c:pt idx="0">
                  <c:v>0</c:v>
                </c:pt>
                <c:pt idx="1">
                  <c:v>4.0367333960643581</c:v>
                </c:pt>
                <c:pt idx="2">
                  <c:v>4.9390829080198042</c:v>
                </c:pt>
                <c:pt idx="3">
                  <c:v>3.8393345703828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03-4104-AFA0-8A708CDEA5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48654064"/>
        <c:axId val="1548653232"/>
      </c:barChart>
      <c:catAx>
        <c:axId val="1548654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15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8653232"/>
        <c:crosses val="autoZero"/>
        <c:auto val="1"/>
        <c:lblAlgn val="ctr"/>
        <c:lblOffset val="100"/>
        <c:noMultiLvlLbl val="0"/>
      </c:catAx>
      <c:valAx>
        <c:axId val="1548653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8654064"/>
        <c:crosses val="autoZero"/>
        <c:crossBetween val="between"/>
        <c:majorUnit val="1"/>
        <c:min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 b="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70253718285214"/>
          <c:y val="5.6632040994351991E-2"/>
          <c:w val="0.76982648002333043"/>
          <c:h val="0.477621515815590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ay 3 C37'!$J$14:$J$17</c:f>
                <c:numCache>
                  <c:formatCode>General</c:formatCode>
                  <c:ptCount val="4"/>
                  <c:pt idx="0">
                    <c:v>0.37266129138385939</c:v>
                  </c:pt>
                  <c:pt idx="1">
                    <c:v>0.93165322845964593</c:v>
                  </c:pt>
                  <c:pt idx="2">
                    <c:v>2.4222983939950837</c:v>
                  </c:pt>
                  <c:pt idx="3">
                    <c:v>0.74532258276771879</c:v>
                  </c:pt>
                </c:numCache>
              </c:numRef>
            </c:plus>
            <c:minus>
              <c:numRef>
                <c:f>'Day 3 C37'!$J$14:$J$17</c:f>
                <c:numCache>
                  <c:formatCode>General</c:formatCode>
                  <c:ptCount val="4"/>
                  <c:pt idx="0">
                    <c:v>0.37266129138385939</c:v>
                  </c:pt>
                  <c:pt idx="1">
                    <c:v>0.93165322845964593</c:v>
                  </c:pt>
                  <c:pt idx="2">
                    <c:v>2.4222983939950837</c:v>
                  </c:pt>
                  <c:pt idx="3">
                    <c:v>0.745322582767718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ay 3 62'!$E$14:$E$17</c:f>
              <c:strCache>
                <c:ptCount val="4"/>
                <c:pt idx="0">
                  <c:v>No HIV/ no drug</c:v>
                </c:pt>
                <c:pt idx="1">
                  <c:v>HIV/no drug</c:v>
                </c:pt>
                <c:pt idx="2">
                  <c:v>HIV+10ug fentanyl</c:v>
                </c:pt>
                <c:pt idx="3">
                  <c:v>HIV+10ug fentanyl+10ug naltrexone</c:v>
                </c:pt>
              </c:strCache>
            </c:strRef>
          </c:cat>
          <c:val>
            <c:numRef>
              <c:f>'Day 3 62'!$J$14:$J$17</c:f>
              <c:numCache>
                <c:formatCode>General</c:formatCode>
                <c:ptCount val="4"/>
                <c:pt idx="0">
                  <c:v>10.377897776594054</c:v>
                </c:pt>
                <c:pt idx="1">
                  <c:v>78.759086931530732</c:v>
                </c:pt>
                <c:pt idx="2">
                  <c:v>100.10350435561503</c:v>
                </c:pt>
                <c:pt idx="3">
                  <c:v>47.5329947740740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FA-48E0-BB6E-353F837903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1243983"/>
        <c:axId val="1884350575"/>
      </c:barChart>
      <c:catAx>
        <c:axId val="14124398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15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84350575"/>
        <c:crosses val="autoZero"/>
        <c:auto val="1"/>
        <c:lblAlgn val="ctr"/>
        <c:lblOffset val="100"/>
        <c:noMultiLvlLbl val="0"/>
      </c:catAx>
      <c:valAx>
        <c:axId val="1884350575"/>
        <c:scaling>
          <c:orientation val="minMax"/>
          <c:max val="1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41243983"/>
        <c:crosses val="autoZero"/>
        <c:crossBetween val="between"/>
        <c:majorUnit val="20"/>
        <c:min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1438</cdr:x>
      <cdr:y>0</cdr:y>
    </cdr:from>
    <cdr:to>
      <cdr:x>0.20254</cdr:x>
      <cdr:y>0.64194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7A2B07ED-FEB2-0D3D-168F-4DB68F46D945}"/>
            </a:ext>
          </a:extLst>
        </cdr:cNvPr>
        <cdr:cNvSpPr txBox="1"/>
      </cdr:nvSpPr>
      <cdr:spPr>
        <a:xfrm xmlns:a="http://schemas.openxmlformats.org/drawingml/2006/main" rot="16200000">
          <a:off x="-191413" y="275921"/>
          <a:ext cx="2212109" cy="5088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DNA proviral load</a:t>
          </a:r>
        </a:p>
        <a:p xmlns:a="http://schemas.openxmlformats.org/drawingml/2006/main">
          <a:pPr algn="ctr"/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(log copies / 1 × 10</a:t>
          </a:r>
          <a:r>
            <a:rPr 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en-US" sz="12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cells</a:t>
          </a:r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9726</cdr:x>
      <cdr:y>0.03942</cdr:y>
    </cdr:from>
    <cdr:to>
      <cdr:x>0.14934</cdr:x>
      <cdr:y>0.5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E865C1D8-282D-4780-8A65-FCD40EC6FDA9}"/>
            </a:ext>
          </a:extLst>
        </cdr:cNvPr>
        <cdr:cNvSpPr txBox="1"/>
      </cdr:nvSpPr>
      <cdr:spPr>
        <a:xfrm xmlns:a="http://schemas.openxmlformats.org/drawingml/2006/main" rot="16200000">
          <a:off x="-129030" y="813394"/>
          <a:ext cx="1637819" cy="2913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200" b="0" i="0" baseline="0" dirty="0">
              <a:effectLst/>
              <a:latin typeface="Times New Roman" panose="02020603050405020304" pitchFamily="18" charset="0"/>
              <a:cs typeface="Times New Roman" panose="02020603050405020304" pitchFamily="18" charset="0"/>
            </a:rPr>
            <a:t>HIV p24 (</a:t>
          </a:r>
          <a:r>
            <a:rPr lang="en-US" sz="1200" b="0" i="0" baseline="0" dirty="0" err="1">
              <a:effectLst/>
              <a:latin typeface="Times New Roman" panose="02020603050405020304" pitchFamily="18" charset="0"/>
              <a:cs typeface="Times New Roman" panose="02020603050405020304" pitchFamily="18" charset="0"/>
            </a:rPr>
            <a:t>pg</a:t>
          </a:r>
          <a:r>
            <a:rPr lang="en-US" sz="1200" b="0" i="0" baseline="0" dirty="0">
              <a:effectLst/>
              <a:latin typeface="Times New Roman" panose="02020603050405020304" pitchFamily="18" charset="0"/>
              <a:cs typeface="Times New Roman" panose="02020603050405020304" pitchFamily="18" charset="0"/>
            </a:rPr>
            <a:t>/mL)</a:t>
          </a:r>
          <a:endParaRPr lang="en-US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A2F3DA-000A-4DE6-A3BE-99D0D354C9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02553C4-CF05-4772-B531-230B528F99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B04892-0688-45C7-9A79-F293E0436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6CA3C7-1845-49B8-8ABF-5A3C52358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27779F-9678-410E-8765-7A43D62B7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262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9799D5-4B95-4A6D-8FF7-E9EC6EF84E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4BFE1C-CAE1-4C10-84C5-E8C0E2C3E8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534CFC-BD24-4608-906B-DEF3C27D8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975078-815F-4FCE-9379-E94CDD720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701445-0758-4032-BCB2-131AA6EB4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237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79EBB2-194A-4E68-B0B6-D50E1B4EC2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E637C5-AE38-4080-8457-543490D443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940B9-5BF5-433D-AAA1-B396F49B6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5557CD-4D2C-443C-AFE2-F07564661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C94330-B7B4-4B42-8D0A-F1C4650980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204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D4F1F2-3703-4E3C-A5D9-A63AB07356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6BE3B6-93FC-46D4-8F27-4CF96A6B2C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524795-62BE-4AB5-83AB-55F055E83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671942-9DB5-47DE-96C4-01BAFEEB8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E1E8FE-90CF-417C-AE37-4C928BB50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302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9C79E8-752D-4701-BC66-D2C5460C89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1E66E0-073F-442A-B0B5-6F53C57701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3D5E89-D772-404D-A73B-CE3ABF254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B1463F-1B5E-4D25-9988-DC696483EE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753913-D9DF-4D14-9C6F-E375BA302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45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8005D8-CE03-45D8-9C72-1EE4E19E02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61019E-CBAB-489D-A8AF-FE79C233EA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F190BC-D10D-40C3-BCEC-54A5997356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649852-6F26-4970-BC71-49F985950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D159DA-70D5-4A49-939C-0D85FAB7C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566E0D-41E8-4727-B916-B735CE986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447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B6D2B5-004C-453D-920B-382F271895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0FAA6C-87FE-4704-A714-50FC9D196A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758DD9-FD59-450B-B5A1-9F2324CD54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4AF34B-C019-403E-97CB-3E07552D50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473D86F-2CEC-49A9-92E9-84DD94AE2F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76ACDE-B83E-416E-B15F-BFBDFD777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5A3A2F-4051-470D-9528-A6C69AAE44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044AB0F-F639-446F-9118-FFEAC14A9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793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DC7B34-1865-49B5-9DEA-85D2F7CB91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0AFA57-2FCD-4473-B018-C151430C03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0A2EA0-FF1B-49D7-AE6F-9A2F9BE7F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98A5B7-E2D6-4A02-8A41-4E9CD9FFD4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609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317BAE-FF66-452F-8F83-C8A801EB0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A4AF3D-A07B-4847-A22B-E48865C6F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323CDF-9698-4CC7-9533-E9AFDA3AF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39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6AD730-210E-4106-BFBB-028F833EEC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3F5C14-6187-4DDD-A717-50B674CC5D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FD81A7-802A-4845-890E-78E653C79D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13BCDD-86BE-4C1F-B6EE-2BA25C8AC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59C2A7-68CA-40CB-B1A1-7A6F8B4E1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7930DC-4334-440B-A9AD-443D3430F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104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9223CA-C184-440E-95EC-B34FD9285D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AA1ECF6-FBD3-4175-ACDC-A9CDB12E4C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CB2A1E-95A8-40E6-A82D-2F3DD3DC1D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A249AD-97C6-4500-B1B5-58A97D975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66F217-B37B-46F1-BDF2-A3D32B5F9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5A39F2-C279-4EE6-AF9F-FBD0F5D3F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188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5BE94B-82B8-4D8A-8060-954B23323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C666AC-A037-4CFB-91CF-B625E9BEE6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71471A-0126-4488-9720-FBED974184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48C6EF-5D85-4B4F-BD9F-C58B5BEE8467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C307B8-97C7-4F2B-A81D-A02A9B3A6A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AB6421-7C8E-4887-AFED-0E44337BCB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578C6F-30BB-4D7D-940F-12A8FCB6C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38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310B051-EEF3-4939-ACDE-B4DEE46E1C09}"/>
              </a:ext>
            </a:extLst>
          </p:cNvPr>
          <p:cNvSpPr txBox="1"/>
          <p:nvPr/>
        </p:nvSpPr>
        <p:spPr>
          <a:xfrm>
            <a:off x="10774393" y="73696"/>
            <a:ext cx="11645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ontrol ID : 62</a:t>
            </a:r>
          </a:p>
          <a:p>
            <a:endParaRPr lang="en-US" sz="1200" dirty="0"/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C709BB86-BDFB-4110-BD84-FEF36B6278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6383681"/>
              </p:ext>
            </p:extLst>
          </p:nvPr>
        </p:nvGraphicFramePr>
        <p:xfrm>
          <a:off x="172528" y="1480953"/>
          <a:ext cx="5772150" cy="34459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63791CBA-6765-4F47-838A-EF70BF8567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3636983"/>
              </p:ext>
            </p:extLst>
          </p:nvPr>
        </p:nvGraphicFramePr>
        <p:xfrm>
          <a:off x="5858415" y="1536702"/>
          <a:ext cx="5595056" cy="3555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5C367B7-6D0A-4ADE-9301-CA7D1FC23FDF}"/>
              </a:ext>
            </a:extLst>
          </p:cNvPr>
          <p:cNvSpPr txBox="1"/>
          <p:nvPr/>
        </p:nvSpPr>
        <p:spPr>
          <a:xfrm>
            <a:off x="0" y="5842337"/>
            <a:ext cx="12192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5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PBMC derived </a:t>
            </a:r>
            <a:r>
              <a:rPr lang="en-US" sz="1200" dirty="0">
                <a:latin typeface="Times New Roman" panose="02020603050405020304" pitchFamily="18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 cells were seeded at ~1 × 10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s per well. 10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 of naltrexone was added into the respective well and the cells are incubated for 24 hrs. After incubation cells were infected with HIV</a:t>
            </a:r>
            <a:r>
              <a:rPr lang="en-US" sz="105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L4-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 at MOI of 1 for 2 hours and rinsed with RPMI + 10% FBS + 1% antibiotics (Pen/Strep) + 1% glutamine for three times to remove any unbound virus and replaced with fresh media. Fentanyl at concentration of 10ug/mL was added to the respective well and incubated. After incubation with drug and virus for 72 hours, HIV proviral DNA was quantified in cells by real-time PCR based on SYBR Green I detection and HIV p24 antigen expression was estimated from the cell culture supernatant. Error bar represents the standard deviations between the replicat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0969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7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uravasal Krishnan, Janani (jananimk)</dc:creator>
  <cp:lastModifiedBy>Madhuravasal Krishnan, Janani (jananimk)</cp:lastModifiedBy>
  <cp:revision>1</cp:revision>
  <dcterms:created xsi:type="dcterms:W3CDTF">2024-06-12T20:08:27Z</dcterms:created>
  <dcterms:modified xsi:type="dcterms:W3CDTF">2024-07-11T18:37:38Z</dcterms:modified>
</cp:coreProperties>
</file>